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679A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7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73776-1AA1-42AD-ABA4-8825C43CACC1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D2AB2-C7F4-4BBB-8BEC-C64813D179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5229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73776-1AA1-42AD-ABA4-8825C43CACC1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D2AB2-C7F4-4BBB-8BEC-C64813D179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86864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73776-1AA1-42AD-ABA4-8825C43CACC1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D2AB2-C7F4-4BBB-8BEC-C64813D179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6886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73776-1AA1-42AD-ABA4-8825C43CACC1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D2AB2-C7F4-4BBB-8BEC-C64813D179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4492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73776-1AA1-42AD-ABA4-8825C43CACC1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D2AB2-C7F4-4BBB-8BEC-C64813D179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6360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73776-1AA1-42AD-ABA4-8825C43CACC1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D2AB2-C7F4-4BBB-8BEC-C64813D179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0130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73776-1AA1-42AD-ABA4-8825C43CACC1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D2AB2-C7F4-4BBB-8BEC-C64813D179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79812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73776-1AA1-42AD-ABA4-8825C43CACC1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D2AB2-C7F4-4BBB-8BEC-C64813D179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428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73776-1AA1-42AD-ABA4-8825C43CACC1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D2AB2-C7F4-4BBB-8BEC-C64813D179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15340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73776-1AA1-42AD-ABA4-8825C43CACC1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D2AB2-C7F4-4BBB-8BEC-C64813D179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05653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73776-1AA1-42AD-ABA4-8825C43CACC1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D2AB2-C7F4-4BBB-8BEC-C64813D179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79101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673776-1AA1-42AD-ABA4-8825C43CACC1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4D2AB2-C7F4-4BBB-8BEC-C64813D179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54106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3509" y="370560"/>
            <a:ext cx="7608428" cy="6125986"/>
          </a:xfrm>
          <a:prstGeom prst="rect">
            <a:avLst/>
          </a:prstGeom>
        </p:spPr>
      </p:pic>
      <p:grpSp>
        <p:nvGrpSpPr>
          <p:cNvPr id="9" name="Groupe 8"/>
          <p:cNvGrpSpPr/>
          <p:nvPr/>
        </p:nvGrpSpPr>
        <p:grpSpPr>
          <a:xfrm>
            <a:off x="9183542" y="5223646"/>
            <a:ext cx="2871766" cy="1334455"/>
            <a:chOff x="10611088" y="5518425"/>
            <a:chExt cx="2871766" cy="1334455"/>
          </a:xfrm>
        </p:grpSpPr>
        <p:grpSp>
          <p:nvGrpSpPr>
            <p:cNvPr id="10" name="Groupe 9"/>
            <p:cNvGrpSpPr/>
            <p:nvPr/>
          </p:nvGrpSpPr>
          <p:grpSpPr>
            <a:xfrm>
              <a:off x="10611088" y="5854016"/>
              <a:ext cx="2871766" cy="998864"/>
              <a:chOff x="155412" y="4783945"/>
              <a:chExt cx="2871766" cy="998864"/>
            </a:xfrm>
          </p:grpSpPr>
          <p:grpSp>
            <p:nvGrpSpPr>
              <p:cNvPr id="13" name="Groupe 12"/>
              <p:cNvGrpSpPr/>
              <p:nvPr/>
            </p:nvGrpSpPr>
            <p:grpSpPr>
              <a:xfrm>
                <a:off x="155412" y="4783945"/>
                <a:ext cx="750256" cy="701958"/>
                <a:chOff x="541256" y="4788542"/>
                <a:chExt cx="750256" cy="701958"/>
              </a:xfrm>
            </p:grpSpPr>
            <p:sp>
              <p:nvSpPr>
                <p:cNvPr id="16" name="ZoneTexte 15"/>
                <p:cNvSpPr txBox="1"/>
                <p:nvPr/>
              </p:nvSpPr>
              <p:spPr>
                <a:xfrm>
                  <a:off x="685256" y="4788542"/>
                  <a:ext cx="60625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i="1" dirty="0" err="1" smtClean="0"/>
                    <a:t>Mild</a:t>
                  </a:r>
                  <a:endParaRPr lang="fr-FR" i="1" dirty="0"/>
                </a:p>
              </p:txBody>
            </p:sp>
            <p:sp>
              <p:nvSpPr>
                <p:cNvPr id="17" name="Rectangle 16"/>
                <p:cNvSpPr/>
                <p:nvPr/>
              </p:nvSpPr>
              <p:spPr>
                <a:xfrm>
                  <a:off x="541256" y="4896159"/>
                  <a:ext cx="144000" cy="144000"/>
                </a:xfrm>
                <a:prstGeom prst="rect">
                  <a:avLst/>
                </a:prstGeom>
                <a:solidFill>
                  <a:srgbClr val="308344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i="1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8" name="ZoneTexte 17"/>
                <p:cNvSpPr txBox="1"/>
                <p:nvPr/>
              </p:nvSpPr>
              <p:spPr>
                <a:xfrm>
                  <a:off x="685256" y="5121168"/>
                  <a:ext cx="56502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i="1" dirty="0" err="1" smtClean="0"/>
                    <a:t>Low</a:t>
                  </a:r>
                  <a:endParaRPr lang="fr-FR" i="1" dirty="0"/>
                </a:p>
              </p:txBody>
            </p:sp>
            <p:sp>
              <p:nvSpPr>
                <p:cNvPr id="19" name="Rectangle 18"/>
                <p:cNvSpPr/>
                <p:nvPr/>
              </p:nvSpPr>
              <p:spPr>
                <a:xfrm>
                  <a:off x="541256" y="5231750"/>
                  <a:ext cx="144000" cy="144000"/>
                </a:xfrm>
                <a:prstGeom prst="rect">
                  <a:avLst/>
                </a:prstGeom>
                <a:solidFill>
                  <a:srgbClr val="4679A4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i="1" dirty="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14" name="ZoneTexte 13"/>
              <p:cNvSpPr txBox="1"/>
              <p:nvPr/>
            </p:nvSpPr>
            <p:spPr>
              <a:xfrm>
                <a:off x="301175" y="5413477"/>
                <a:ext cx="272600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 smtClean="0"/>
                  <a:t>Rectal </a:t>
                </a:r>
                <a:r>
                  <a:rPr lang="fr-FR" dirty="0" err="1" smtClean="0"/>
                  <a:t>swab</a:t>
                </a:r>
                <a:r>
                  <a:rPr lang="fr-FR" dirty="0" smtClean="0"/>
                  <a:t> not </a:t>
                </a:r>
                <a:r>
                  <a:rPr lang="fr-FR" dirty="0"/>
                  <a:t>performed</a:t>
                </a:r>
              </a:p>
            </p:txBody>
          </p:sp>
          <p:sp>
            <p:nvSpPr>
              <p:cNvPr id="15" name="Rectangle 14"/>
              <p:cNvSpPr/>
              <p:nvPr/>
            </p:nvSpPr>
            <p:spPr>
              <a:xfrm>
                <a:off x="155412" y="5526143"/>
                <a:ext cx="144000" cy="144000"/>
              </a:xfrm>
              <a:prstGeom prst="rect">
                <a:avLst/>
              </a:prstGeom>
              <a:solidFill>
                <a:srgbClr val="F0F0F0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i="1" dirty="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11" name="ZoneTexte 10"/>
            <p:cNvSpPr txBox="1"/>
            <p:nvPr/>
          </p:nvSpPr>
          <p:spPr>
            <a:xfrm>
              <a:off x="10755088" y="5518425"/>
              <a:ext cx="6190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i="1" dirty="0" smtClean="0"/>
                <a:t>High</a:t>
              </a:r>
              <a:endParaRPr lang="fr-FR" i="1" dirty="0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10611088" y="5630580"/>
              <a:ext cx="144000" cy="144000"/>
            </a:xfrm>
            <a:prstGeom prst="rect">
              <a:avLst/>
            </a:prstGeom>
            <a:solidFill>
              <a:srgbClr val="CC243C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i="1" dirty="0">
                <a:solidFill>
                  <a:schemeClr val="tx1"/>
                </a:solidFill>
              </a:endParaRPr>
            </a:p>
          </p:txBody>
        </p:sp>
      </p:grpSp>
      <p:sp>
        <p:nvSpPr>
          <p:cNvPr id="20" name="Rectangle 19"/>
          <p:cNvSpPr/>
          <p:nvPr/>
        </p:nvSpPr>
        <p:spPr>
          <a:xfrm>
            <a:off x="690333" y="6459808"/>
            <a:ext cx="10286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i="1" dirty="0"/>
              <a:t>1st </a:t>
            </a:r>
            <a:r>
              <a:rPr lang="fr-FR" b="1" i="1" dirty="0" err="1" smtClean="0"/>
              <a:t>swab</a:t>
            </a:r>
            <a:endParaRPr lang="fr-FR" b="1" i="1" dirty="0"/>
          </a:p>
        </p:txBody>
      </p:sp>
      <p:sp>
        <p:nvSpPr>
          <p:cNvPr id="21" name="Rectangle 20"/>
          <p:cNvSpPr/>
          <p:nvPr/>
        </p:nvSpPr>
        <p:spPr>
          <a:xfrm>
            <a:off x="2886787" y="6459808"/>
            <a:ext cx="11034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i="1" dirty="0"/>
              <a:t>2nd </a:t>
            </a:r>
            <a:r>
              <a:rPr lang="fr-FR" b="1" i="1" dirty="0" err="1" smtClean="0"/>
              <a:t>swab</a:t>
            </a:r>
            <a:endParaRPr lang="fr-FR" b="1" i="1" dirty="0"/>
          </a:p>
        </p:txBody>
      </p:sp>
      <p:sp>
        <p:nvSpPr>
          <p:cNvPr id="22" name="Rectangle 21"/>
          <p:cNvSpPr/>
          <p:nvPr/>
        </p:nvSpPr>
        <p:spPr>
          <a:xfrm>
            <a:off x="5158069" y="6459808"/>
            <a:ext cx="106336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i="1" dirty="0"/>
              <a:t>3rd </a:t>
            </a:r>
            <a:r>
              <a:rPr lang="fr-FR" b="1" i="1" dirty="0" err="1" smtClean="0"/>
              <a:t>swab</a:t>
            </a:r>
            <a:endParaRPr lang="fr-FR" b="1" i="1" dirty="0"/>
          </a:p>
        </p:txBody>
      </p:sp>
      <p:sp>
        <p:nvSpPr>
          <p:cNvPr id="23" name="Rectangle 22"/>
          <p:cNvSpPr/>
          <p:nvPr/>
        </p:nvSpPr>
        <p:spPr>
          <a:xfrm>
            <a:off x="7372091" y="6457809"/>
            <a:ext cx="10617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i="1" dirty="0"/>
              <a:t>4th </a:t>
            </a:r>
            <a:r>
              <a:rPr lang="fr-FR" b="1" i="1" dirty="0" err="1" smtClean="0"/>
              <a:t>swab</a:t>
            </a:r>
            <a:endParaRPr lang="fr-FR" b="1" i="1" dirty="0"/>
          </a:p>
        </p:txBody>
      </p:sp>
      <p:sp>
        <p:nvSpPr>
          <p:cNvPr id="25" name="Rectangle 24"/>
          <p:cNvSpPr/>
          <p:nvPr/>
        </p:nvSpPr>
        <p:spPr>
          <a:xfrm>
            <a:off x="8433857" y="4870674"/>
            <a:ext cx="37714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800" b="1" i="0" u="sng" strike="noStrike" kern="1200" spc="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GB" b="1" u="sng" dirty="0" smtClean="0"/>
              <a:t>ESBL-E Relative </a:t>
            </a:r>
            <a:r>
              <a:rPr lang="en-GB" b="1" u="sng" dirty="0" smtClean="0"/>
              <a:t>abundance categories</a:t>
            </a:r>
            <a:endParaRPr lang="en-GB" b="1" u="sng" dirty="0"/>
          </a:p>
        </p:txBody>
      </p:sp>
    </p:spTree>
    <p:extLst>
      <p:ext uri="{BB962C8B-B14F-4D97-AF65-F5344CB8AC3E}">
        <p14:creationId xmlns:p14="http://schemas.microsoft.com/office/powerpoint/2010/main" val="273945096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</TotalTime>
  <Words>19</Words>
  <Application>Microsoft Office PowerPoint</Application>
  <PresentationFormat>Grand écran</PresentationFormat>
  <Paragraphs>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AP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AY Pierre</dc:creator>
  <cp:lastModifiedBy>Keyvan RAZAZI</cp:lastModifiedBy>
  <cp:revision>10</cp:revision>
  <dcterms:created xsi:type="dcterms:W3CDTF">2024-07-22T13:14:40Z</dcterms:created>
  <dcterms:modified xsi:type="dcterms:W3CDTF">2024-07-24T15:19:27Z</dcterms:modified>
</cp:coreProperties>
</file>